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0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74ED6"/>
    <a:srgbClr val="05BE78"/>
    <a:srgbClr val="FF8080"/>
    <a:srgbClr val="FFFFFF"/>
    <a:srgbClr val="0000FF"/>
    <a:srgbClr val="76069A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75"/>
    <p:restoredTop sz="94682"/>
  </p:normalViewPr>
  <p:slideViewPr>
    <p:cSldViewPr snapToGrid="0">
      <p:cViewPr varScale="1">
        <p:scale>
          <a:sx n="69" d="100"/>
          <a:sy n="69" d="100"/>
        </p:scale>
        <p:origin x="1788" y="84"/>
      </p:cViewPr>
      <p:guideLst>
        <p:guide orient="horz" pos="16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2781702D-12D0-4839-A3CC-B3169D578D6E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2225" y="1143000"/>
            <a:ext cx="173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6319DB23-573F-4C71-BB24-19F8F211E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79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48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6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34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43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0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7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41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06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75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802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6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7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Rectangle 21">
            <a:extLst>
              <a:ext uri="{FF2B5EF4-FFF2-40B4-BE49-F238E27FC236}">
                <a16:creationId xmlns:a16="http://schemas.microsoft.com/office/drawing/2014/main" id="{7FD4BA39-394A-DF95-1B96-2127DB48E158}"/>
              </a:ext>
            </a:extLst>
          </p:cNvPr>
          <p:cNvSpPr/>
          <p:nvPr/>
        </p:nvSpPr>
        <p:spPr>
          <a:xfrm>
            <a:off x="1767641" y="3462002"/>
            <a:ext cx="961875" cy="69265"/>
          </a:xfrm>
          <a:prstGeom prst="rect">
            <a:avLst/>
          </a:prstGeom>
          <a:solidFill>
            <a:srgbClr val="FF960B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FE26E4A-1194-3B98-9638-AD5B5D682604}"/>
              </a:ext>
            </a:extLst>
          </p:cNvPr>
          <p:cNvSpPr txBox="1"/>
          <p:nvPr/>
        </p:nvSpPr>
        <p:spPr>
          <a:xfrm>
            <a:off x="1162686" y="1031879"/>
            <a:ext cx="766511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TC3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447F92E-BD9F-9537-5DEC-F8CE47476A19}"/>
              </a:ext>
            </a:extLst>
          </p:cNvPr>
          <p:cNvSpPr txBox="1"/>
          <p:nvPr/>
        </p:nvSpPr>
        <p:spPr>
          <a:xfrm>
            <a:off x="2878648" y="3531267"/>
            <a:ext cx="20858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Hu-CD34+ post</a:t>
            </a:r>
          </a:p>
          <a:p>
            <a:pPr algn="ctr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radiation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8888E1C-8525-6EA1-73CB-DF880ECB5D96}"/>
              </a:ext>
            </a:extLst>
          </p:cNvPr>
          <p:cNvSpPr txBox="1"/>
          <p:nvPr/>
        </p:nvSpPr>
        <p:spPr>
          <a:xfrm>
            <a:off x="4107513" y="3531267"/>
            <a:ext cx="19074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NSG post</a:t>
            </a:r>
          </a:p>
          <a:p>
            <a:pPr algn="ctr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radiation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22A66648-E47E-25E8-1683-E1B14D2341D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244"/>
          <a:stretch/>
        </p:blipFill>
        <p:spPr>
          <a:xfrm>
            <a:off x="2893180" y="1355045"/>
            <a:ext cx="2713254" cy="217650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E4F6F72-5EF8-99D3-E77F-B567F19CA8D6}"/>
              </a:ext>
            </a:extLst>
          </p:cNvPr>
          <p:cNvSpPr txBox="1"/>
          <p:nvPr/>
        </p:nvSpPr>
        <p:spPr>
          <a:xfrm>
            <a:off x="1601190" y="3531267"/>
            <a:ext cx="13272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NSG post</a:t>
            </a:r>
          </a:p>
          <a:p>
            <a:pPr algn="ctr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radiatio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EC1B81C-CAD0-7B2A-B54A-974C5960EFAB}"/>
              </a:ext>
            </a:extLst>
          </p:cNvPr>
          <p:cNvSpPr txBox="1"/>
          <p:nvPr/>
        </p:nvSpPr>
        <p:spPr>
          <a:xfrm>
            <a:off x="12323" y="3531267"/>
            <a:ext cx="21176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Hu-CD34+ post</a:t>
            </a:r>
          </a:p>
          <a:p>
            <a:pPr algn="ctr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radiation 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7AD800D4-0F8C-EF54-AD3C-160007B41F6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77149" y="1725104"/>
            <a:ext cx="980851" cy="1147598"/>
          </a:xfrm>
          <a:prstGeom prst="rect">
            <a:avLst/>
          </a:prstGeom>
        </p:spPr>
      </p:pic>
      <p:grpSp>
        <p:nvGrpSpPr>
          <p:cNvPr id="11" name="Group 10">
            <a:extLst>
              <a:ext uri="{FF2B5EF4-FFF2-40B4-BE49-F238E27FC236}">
                <a16:creationId xmlns:a16="http://schemas.microsoft.com/office/drawing/2014/main" id="{D3294DD3-BF8F-19B8-0352-B490151D96AB}"/>
              </a:ext>
            </a:extLst>
          </p:cNvPr>
          <p:cNvGrpSpPr/>
          <p:nvPr/>
        </p:nvGrpSpPr>
        <p:grpSpPr>
          <a:xfrm>
            <a:off x="112468" y="1400360"/>
            <a:ext cx="2617944" cy="2096025"/>
            <a:chOff x="-5005232" y="2748560"/>
            <a:chExt cx="3876028" cy="2875210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91EC4D23-85B1-69EB-4BB8-2A0EB8EEA47C}"/>
                </a:ext>
              </a:extLst>
            </p:cNvPr>
            <p:cNvGrpSpPr/>
            <p:nvPr/>
          </p:nvGrpSpPr>
          <p:grpSpPr>
            <a:xfrm>
              <a:off x="-5005232" y="2748560"/>
              <a:ext cx="3876028" cy="2875210"/>
              <a:chOff x="-5005232" y="2748560"/>
              <a:chExt cx="3876028" cy="2875210"/>
            </a:xfrm>
          </p:grpSpPr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0DC7E4F3-0363-5056-9E51-016480D3CCD0}"/>
                  </a:ext>
                </a:extLst>
              </p:cNvPr>
              <p:cNvGrpSpPr/>
              <p:nvPr/>
            </p:nvGrpSpPr>
            <p:grpSpPr>
              <a:xfrm>
                <a:off x="-5005232" y="3069196"/>
                <a:ext cx="3876028" cy="2554574"/>
                <a:chOff x="-5005232" y="3069196"/>
                <a:chExt cx="3876028" cy="2554574"/>
              </a:xfrm>
            </p:grpSpPr>
            <p:pic>
              <p:nvPicPr>
                <p:cNvPr id="20" name="Picture 19">
                  <a:extLst>
                    <a:ext uri="{FF2B5EF4-FFF2-40B4-BE49-F238E27FC236}">
                      <a16:creationId xmlns:a16="http://schemas.microsoft.com/office/drawing/2014/main" id="{9993F453-6583-1D0E-B13D-24E467206D0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14524" t="20753" r="7081"/>
                <a:stretch/>
              </p:blipFill>
              <p:spPr>
                <a:xfrm rot="10800000">
                  <a:off x="-4691500" y="3069196"/>
                  <a:ext cx="3562296" cy="2513945"/>
                </a:xfrm>
                <a:prstGeom prst="rect">
                  <a:avLst/>
                </a:prstGeom>
              </p:spPr>
            </p:pic>
            <p:pic>
              <p:nvPicPr>
                <p:cNvPr id="19" name="Picture 18">
                  <a:extLst>
                    <a:ext uri="{FF2B5EF4-FFF2-40B4-BE49-F238E27FC236}">
                      <a16:creationId xmlns:a16="http://schemas.microsoft.com/office/drawing/2014/main" id="{9DF38C0A-60B8-4245-DC71-1810BCF9AD5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6653" t="20457" r="85756" b="2030"/>
                <a:stretch/>
              </p:blipFill>
              <p:spPr>
                <a:xfrm>
                  <a:off x="-5005232" y="3164819"/>
                  <a:ext cx="344941" cy="2458951"/>
                </a:xfrm>
                <a:prstGeom prst="rect">
                  <a:avLst/>
                </a:prstGeom>
              </p:spPr>
            </p:pic>
          </p:grpSp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3B494940-F5FF-C35E-C1C2-6AC78A0F5B2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-2578530" y="2748560"/>
                <a:ext cx="1448002" cy="428685"/>
              </a:xfrm>
              <a:prstGeom prst="rect">
                <a:avLst/>
              </a:prstGeom>
            </p:spPr>
          </p:pic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AD84C895-CCB8-AE1D-9B6A-CA99E7F386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-4665864" y="2843823"/>
                <a:ext cx="2143424" cy="333422"/>
              </a:xfrm>
              <a:prstGeom prst="rect">
                <a:avLst/>
              </a:prstGeom>
            </p:spPr>
          </p:pic>
        </p:grp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12527860-3009-F510-7940-7B3FA8659EA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3450866" y="2748560"/>
              <a:ext cx="0" cy="182538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D9BA392B-9C1C-E4F2-8DB4-B0BDF2375F5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1986502" y="2748560"/>
              <a:ext cx="0" cy="261974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2AB07673-5E6A-5C29-9388-ADCAD1F2D3FD}"/>
                </a:ext>
              </a:extLst>
            </p:cNvPr>
            <p:cNvCxnSpPr>
              <a:cxnSpLocks/>
            </p:cNvCxnSpPr>
            <p:nvPr/>
          </p:nvCxnSpPr>
          <p:spPr>
            <a:xfrm>
              <a:off x="-3450866" y="2748560"/>
              <a:ext cx="1464366" cy="0"/>
            </a:xfrm>
            <a:prstGeom prst="line">
              <a:avLst/>
            </a:prstGeom>
            <a:ln w="9525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1" name="Rectangle 20">
            <a:extLst>
              <a:ext uri="{FF2B5EF4-FFF2-40B4-BE49-F238E27FC236}">
                <a16:creationId xmlns:a16="http://schemas.microsoft.com/office/drawing/2014/main" id="{6C664DA6-25AA-D98E-39B4-93371957B3FD}"/>
              </a:ext>
            </a:extLst>
          </p:cNvPr>
          <p:cNvSpPr/>
          <p:nvPr/>
        </p:nvSpPr>
        <p:spPr>
          <a:xfrm>
            <a:off x="341685" y="3466766"/>
            <a:ext cx="1425958" cy="64788"/>
          </a:xfrm>
          <a:prstGeom prst="rect">
            <a:avLst/>
          </a:prstGeom>
          <a:solidFill>
            <a:srgbClr val="8B2F63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3D661E1-3041-7301-53F5-3CE015F8E6FB}"/>
              </a:ext>
            </a:extLst>
          </p:cNvPr>
          <p:cNvSpPr txBox="1"/>
          <p:nvPr/>
        </p:nvSpPr>
        <p:spPr>
          <a:xfrm>
            <a:off x="4096483" y="1031879"/>
            <a:ext cx="728457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A67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84655CE-FF26-60E7-6AFB-8EDDF6303082}"/>
              </a:ext>
            </a:extLst>
          </p:cNvPr>
          <p:cNvSpPr txBox="1"/>
          <p:nvPr/>
        </p:nvSpPr>
        <p:spPr>
          <a:xfrm>
            <a:off x="112251" y="4317033"/>
            <a:ext cx="6345541" cy="14465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145540" algn="l"/>
              </a:tabLst>
            </a:pPr>
            <a:r>
              <a:rPr lang="en-US" sz="11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11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istinct tumor transcriptional signatures following radiation therapy are noted in Ewing sarcomas developed in hu-cD34+ versus NSG mouse models.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Bulk RNA sequencing was performed on Ewing sarcoma tumors (TC32 and A673) developed in immunocompetent (hu-CD34+) and immunodeficient (NSG) mice and treated with focal radiation therapy. Unsupervised clustering demonstrates that radiated tumors developed in hu-CD34+ mice or NSG mice cluster separately in both cell lines tested. n=9 fo</a:t>
            </a:r>
            <a:r>
              <a:rPr lang="en-US" sz="11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r hu mice with TC32 derived tumors, n = 6 for NSG mice with TC32 derived tumors, n=6 for hu-mice with A673 derived tumors, n=6 for NSG mice with A673 derived tumors. </a:t>
            </a:r>
            <a:endParaRPr lang="en-US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66821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38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ley, Jessica</dc:creator>
  <cp:lastModifiedBy>Bailey, Kelly Margaret</cp:lastModifiedBy>
  <cp:revision>5</cp:revision>
  <cp:lastPrinted>2025-05-16T17:21:58Z</cp:lastPrinted>
  <dcterms:created xsi:type="dcterms:W3CDTF">2024-03-08T16:05:53Z</dcterms:created>
  <dcterms:modified xsi:type="dcterms:W3CDTF">2025-07-22T15:12:46Z</dcterms:modified>
</cp:coreProperties>
</file>